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6" r:id="rId2"/>
    <p:sldId id="277" r:id="rId3"/>
    <p:sldId id="273" r:id="rId4"/>
  </p:sldIdLst>
  <p:sldSz cx="6858000" cy="9144000" type="letter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22" autoAdjust="0"/>
    <p:restoredTop sz="94660"/>
  </p:normalViewPr>
  <p:slideViewPr>
    <p:cSldViewPr snapToGrid="0">
      <p:cViewPr>
        <p:scale>
          <a:sx n="155" d="100"/>
          <a:sy n="155" d="100"/>
        </p:scale>
        <p:origin x="2224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768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023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543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6801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32831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039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410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812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989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0607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22661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62A9E-604A-4A2C-8CE8-5A1A6C8D2144}" type="datetimeFigureOut">
              <a:rPr kumimoji="1" lang="ja-JP" altLang="en-US" smtClean="0"/>
              <a:t>2019/4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56357-0251-4953-A9B8-633A05DE8E9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9436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8C61969-9241-A24B-A7C4-6284130F95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938" y="3148762"/>
            <a:ext cx="6033672" cy="2620441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94EC454D-F0C9-0F42-B66D-77960A2C9332}"/>
              </a:ext>
            </a:extLst>
          </p:cNvPr>
          <p:cNvSpPr/>
          <p:nvPr/>
        </p:nvSpPr>
        <p:spPr>
          <a:xfrm>
            <a:off x="140412" y="106235"/>
            <a:ext cx="1266693" cy="2482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13" dirty="0"/>
              <a:t>Supplementary Fig 1</a:t>
            </a:r>
          </a:p>
        </p:txBody>
      </p:sp>
    </p:spTree>
    <p:extLst>
      <p:ext uri="{BB962C8B-B14F-4D97-AF65-F5344CB8AC3E}">
        <p14:creationId xmlns:p14="http://schemas.microsoft.com/office/powerpoint/2010/main" val="1080245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94EC454D-F0C9-0F42-B66D-77960A2C9332}"/>
              </a:ext>
            </a:extLst>
          </p:cNvPr>
          <p:cNvSpPr/>
          <p:nvPr/>
        </p:nvSpPr>
        <p:spPr>
          <a:xfrm>
            <a:off x="67994" y="68648"/>
            <a:ext cx="1266693" cy="2482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13" dirty="0"/>
              <a:t>Supplementary Fig 2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F8353EA4-ED6D-834F-9172-B4FFE7ECBDBB}"/>
              </a:ext>
            </a:extLst>
          </p:cNvPr>
          <p:cNvGrpSpPr/>
          <p:nvPr/>
        </p:nvGrpSpPr>
        <p:grpSpPr>
          <a:xfrm>
            <a:off x="1027674" y="2080112"/>
            <a:ext cx="4263798" cy="5059975"/>
            <a:chOff x="1158302" y="3454400"/>
            <a:chExt cx="4263798" cy="5059975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FCD10586-D842-7542-9531-E8A9D106C40E}"/>
                </a:ext>
              </a:extLst>
            </p:cNvPr>
            <p:cNvSpPr txBox="1"/>
            <p:nvPr/>
          </p:nvSpPr>
          <p:spPr>
            <a:xfrm rot="16200000">
              <a:off x="634184" y="5419653"/>
              <a:ext cx="14175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Fluorescenc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D10D75C-7AD9-1B4D-8239-C5A264111DE2}"/>
                </a:ext>
              </a:extLst>
            </p:cNvPr>
            <p:cNvSpPr txBox="1"/>
            <p:nvPr/>
          </p:nvSpPr>
          <p:spPr>
            <a:xfrm>
              <a:off x="3238459" y="8145043"/>
              <a:ext cx="96494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ize (kb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3AB96C4-0FCD-B041-9606-C64F9560523D}"/>
                </a:ext>
              </a:extLst>
            </p:cNvPr>
            <p:cNvSpPr txBox="1"/>
            <p:nvPr/>
          </p:nvSpPr>
          <p:spPr>
            <a:xfrm>
              <a:off x="1553206" y="424678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00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AEB921D-177C-834F-9532-B859F668537D}"/>
                </a:ext>
              </a:extLst>
            </p:cNvPr>
            <p:cNvSpPr txBox="1"/>
            <p:nvPr/>
          </p:nvSpPr>
          <p:spPr>
            <a:xfrm>
              <a:off x="1553206" y="3570808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/>
                <a:t>120</a:t>
              </a:r>
            </a:p>
          </p:txBody>
        </p: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D0C4B421-4CA0-0645-8805-6064255347AE}"/>
                </a:ext>
              </a:extLst>
            </p:cNvPr>
            <p:cNvGrpSpPr/>
            <p:nvPr/>
          </p:nvGrpSpPr>
          <p:grpSpPr>
            <a:xfrm>
              <a:off x="1604502" y="3454400"/>
              <a:ext cx="3817598" cy="4690643"/>
              <a:chOff x="1604502" y="3454400"/>
              <a:chExt cx="3817598" cy="4690643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4012E9BF-C2D2-E04C-A58A-68BF540DD4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8703" t="3877" r="1" b="4957"/>
              <a:stretch/>
            </p:blipFill>
            <p:spPr>
              <a:xfrm>
                <a:off x="1848430" y="3454400"/>
                <a:ext cx="3573670" cy="4528974"/>
              </a:xfrm>
              <a:prstGeom prst="rect">
                <a:avLst/>
              </a:prstGeom>
            </p:spPr>
          </p:pic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35EA4F1-4C94-3F4A-ABC8-C3748CB94994}"/>
                  </a:ext>
                </a:extLst>
              </p:cNvPr>
              <p:cNvSpPr txBox="1"/>
              <p:nvPr/>
            </p:nvSpPr>
            <p:spPr>
              <a:xfrm>
                <a:off x="1655798" y="7651234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0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56C8879-556F-7444-8802-AAFDB54D17CA}"/>
                  </a:ext>
                </a:extLst>
              </p:cNvPr>
              <p:cNvSpPr txBox="1"/>
              <p:nvPr/>
            </p:nvSpPr>
            <p:spPr>
              <a:xfrm>
                <a:off x="1604502" y="6975254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20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543558D8-5C6D-B24A-A723-634ADE7E3A54}"/>
                  </a:ext>
                </a:extLst>
              </p:cNvPr>
              <p:cNvSpPr txBox="1"/>
              <p:nvPr/>
            </p:nvSpPr>
            <p:spPr>
              <a:xfrm>
                <a:off x="1604502" y="6280299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40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864E4C9D-C479-B44F-A433-7A417FD9DA72}"/>
                  </a:ext>
                </a:extLst>
              </p:cNvPr>
              <p:cNvSpPr txBox="1"/>
              <p:nvPr/>
            </p:nvSpPr>
            <p:spPr>
              <a:xfrm>
                <a:off x="1604502" y="5604319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6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D31C1F8C-FACF-924C-820B-213084F2E746}"/>
                  </a:ext>
                </a:extLst>
              </p:cNvPr>
              <p:cNvSpPr txBox="1"/>
              <p:nvPr/>
            </p:nvSpPr>
            <p:spPr>
              <a:xfrm>
                <a:off x="1604502" y="4932255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/>
                  <a:t>80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FFA3F94F-47F9-DD44-B010-7922426B5667}"/>
                  </a:ext>
                </a:extLst>
              </p:cNvPr>
              <p:cNvSpPr txBox="1"/>
              <p:nvPr/>
            </p:nvSpPr>
            <p:spPr>
              <a:xfrm>
                <a:off x="1937330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0.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D02042F1-9C77-CA4C-9652-70AA7B9A35D7}"/>
                  </a:ext>
                </a:extLst>
              </p:cNvPr>
              <p:cNvSpPr txBox="1"/>
              <p:nvPr/>
            </p:nvSpPr>
            <p:spPr>
              <a:xfrm>
                <a:off x="2199421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0.2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449E7A1-A3B9-E643-A07F-6FEEE7F08F81}"/>
                  </a:ext>
                </a:extLst>
              </p:cNvPr>
              <p:cNvSpPr txBox="1"/>
              <p:nvPr/>
            </p:nvSpPr>
            <p:spPr>
              <a:xfrm>
                <a:off x="2625058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0.3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14E1FE5-0E21-A748-8897-74DD468D2E22}"/>
                  </a:ext>
                </a:extLst>
              </p:cNvPr>
              <p:cNvSpPr txBox="1"/>
              <p:nvPr/>
            </p:nvSpPr>
            <p:spPr>
              <a:xfrm>
                <a:off x="3005170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0.5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E6F34C7-CA18-214A-AB82-529A93A34202}"/>
                  </a:ext>
                </a:extLst>
              </p:cNvPr>
              <p:cNvSpPr txBox="1"/>
              <p:nvPr/>
            </p:nvSpPr>
            <p:spPr>
              <a:xfrm>
                <a:off x="3252282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0.7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E7FA18F8-E48C-5F4F-8D10-2031B5040742}"/>
                  </a:ext>
                </a:extLst>
              </p:cNvPr>
              <p:cNvSpPr txBox="1"/>
              <p:nvPr/>
            </p:nvSpPr>
            <p:spPr>
              <a:xfrm>
                <a:off x="3447729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1.1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813A0348-0C67-E844-8BB7-61A95C5A444E}"/>
                  </a:ext>
                </a:extLst>
              </p:cNvPr>
              <p:cNvSpPr txBox="1"/>
              <p:nvPr/>
            </p:nvSpPr>
            <p:spPr>
              <a:xfrm>
                <a:off x="3580508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1.9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C0ADBFD-2263-054B-A1CE-259C2DA12972}"/>
                  </a:ext>
                </a:extLst>
              </p:cNvPr>
              <p:cNvSpPr txBox="1"/>
              <p:nvPr/>
            </p:nvSpPr>
            <p:spPr>
              <a:xfrm>
                <a:off x="3700755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2.1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00C48F4D-C313-4D4F-8569-82849C9434BB}"/>
                  </a:ext>
                </a:extLst>
              </p:cNvPr>
              <p:cNvSpPr txBox="1"/>
              <p:nvPr/>
            </p:nvSpPr>
            <p:spPr>
              <a:xfrm>
                <a:off x="3811763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4.9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6CD160F6-6137-8546-A0CB-CE54E6A970E9}"/>
                  </a:ext>
                </a:extLst>
              </p:cNvPr>
              <p:cNvSpPr txBox="1"/>
              <p:nvPr/>
            </p:nvSpPr>
            <p:spPr>
              <a:xfrm>
                <a:off x="3912102" y="7960377"/>
                <a:ext cx="2808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7.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1C2EE83-6EE5-E349-9DC5-86709DD2F6D7}"/>
                  </a:ext>
                </a:extLst>
              </p:cNvPr>
              <p:cNvSpPr txBox="1"/>
              <p:nvPr/>
            </p:nvSpPr>
            <p:spPr>
              <a:xfrm>
                <a:off x="4017024" y="7960377"/>
                <a:ext cx="31931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10.0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4D5E674-6F3E-A847-BDD4-94CD80837E53}"/>
                  </a:ext>
                </a:extLst>
              </p:cNvPr>
              <p:cNvSpPr txBox="1"/>
              <p:nvPr/>
            </p:nvSpPr>
            <p:spPr>
              <a:xfrm>
                <a:off x="4170487" y="7960377"/>
                <a:ext cx="31931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/>
                  <a:t>40.0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68645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38C548F3-0BF8-48F5-A583-447221926407}"/>
              </a:ext>
            </a:extLst>
          </p:cNvPr>
          <p:cNvSpPr/>
          <p:nvPr/>
        </p:nvSpPr>
        <p:spPr>
          <a:xfrm>
            <a:off x="17503" y="103122"/>
            <a:ext cx="1266693" cy="24820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13" dirty="0"/>
              <a:t>Supplementary Fig 3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BD215515-C1EA-47F0-A338-869C4C7AAB3B}"/>
              </a:ext>
            </a:extLst>
          </p:cNvPr>
          <p:cNvGrpSpPr/>
          <p:nvPr/>
        </p:nvGrpSpPr>
        <p:grpSpPr>
          <a:xfrm>
            <a:off x="87636" y="3078905"/>
            <a:ext cx="6682469" cy="3396748"/>
            <a:chOff x="155796" y="774608"/>
            <a:chExt cx="11879945" cy="6038663"/>
          </a:xfrm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E46367D-7883-4DB2-9C7B-BCFBE11A00A3}"/>
                </a:ext>
              </a:extLst>
            </p:cNvPr>
            <p:cNvGrpSpPr/>
            <p:nvPr/>
          </p:nvGrpSpPr>
          <p:grpSpPr>
            <a:xfrm>
              <a:off x="313281" y="1163322"/>
              <a:ext cx="11682199" cy="3772945"/>
              <a:chOff x="313281" y="1163322"/>
              <a:chExt cx="11682199" cy="3772945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A745313C-D659-45BF-9AA9-42F14968C75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313281" y="1163322"/>
                <a:ext cx="5813755" cy="3772945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4F431F5F-786D-4C4C-9F47-A51C7ECD320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6181725" y="1249178"/>
                <a:ext cx="5813755" cy="3677455"/>
              </a:xfrm>
              <a:prstGeom prst="rect">
                <a:avLst/>
              </a:prstGeom>
            </p:spPr>
          </p:pic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D0BD63F1-76EC-465F-A494-D07B3CC01A92}"/>
                </a:ext>
              </a:extLst>
            </p:cNvPr>
            <p:cNvGrpSpPr/>
            <p:nvPr/>
          </p:nvGrpSpPr>
          <p:grpSpPr>
            <a:xfrm>
              <a:off x="1423686" y="1500854"/>
              <a:ext cx="1097280" cy="1610799"/>
              <a:chOff x="1423686" y="1500854"/>
              <a:chExt cx="1097280" cy="1610799"/>
            </a:xfrm>
          </p:grpSpPr>
          <p:cxnSp>
            <p:nvCxnSpPr>
              <p:cNvPr id="3" name="Straight Connector 2">
                <a:extLst>
                  <a:ext uri="{FF2B5EF4-FFF2-40B4-BE49-F238E27FC236}">
                    <a16:creationId xmlns:a16="http://schemas.microsoft.com/office/drawing/2014/main" id="{03C99552-1E3C-475D-9468-94EBCC6E4E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27544" y="1740053"/>
                <a:ext cx="0" cy="137160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>
                <a:extLst>
                  <a:ext uri="{FF2B5EF4-FFF2-40B4-BE49-F238E27FC236}">
                    <a16:creationId xmlns:a16="http://schemas.microsoft.com/office/drawing/2014/main" id="{B9153066-6F2C-422D-B6CD-C097A7C385A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423686" y="1736196"/>
                <a:ext cx="109728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3E893468-19F5-48D6-BF2E-F96EAEB01C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20966" y="1728484"/>
                <a:ext cx="0" cy="46299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5571F644-ABA7-41E9-A032-1055CAA0024C}"/>
                  </a:ext>
                </a:extLst>
              </p:cNvPr>
              <p:cNvSpPr txBox="1"/>
              <p:nvPr/>
            </p:nvSpPr>
            <p:spPr>
              <a:xfrm>
                <a:off x="1635885" y="1500854"/>
                <a:ext cx="647129" cy="4412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13" dirty="0"/>
                  <a:t>*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18224DB-7288-4F89-B221-8EA9C4AA0A8E}"/>
                </a:ext>
              </a:extLst>
            </p:cNvPr>
            <p:cNvSpPr txBox="1"/>
            <p:nvPr/>
          </p:nvSpPr>
          <p:spPr>
            <a:xfrm>
              <a:off x="466845" y="4955554"/>
              <a:ext cx="5416951" cy="1857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88" dirty="0"/>
                <a:t>Method #1 Vs Method #2,  P =0.024, P≤ 0.05</a:t>
              </a:r>
            </a:p>
            <a:p>
              <a:r>
                <a:rPr lang="en-US" sz="788" dirty="0"/>
                <a:t>Method #1 Vs Method #3,  P =0.392, </a:t>
              </a:r>
            </a:p>
            <a:p>
              <a:r>
                <a:rPr lang="en-US" sz="788" dirty="0"/>
                <a:t>Method #1 Vs Method #4,  P =0.198</a:t>
              </a:r>
            </a:p>
            <a:p>
              <a:r>
                <a:rPr lang="en-US" sz="788" dirty="0"/>
                <a:t>Method #2 Vs Method #3,  P =0.424, </a:t>
              </a:r>
            </a:p>
            <a:p>
              <a:r>
                <a:rPr lang="en-US" sz="788" dirty="0"/>
                <a:t>Method #2 Vs Method #4,  P =0.247,</a:t>
              </a:r>
            </a:p>
            <a:p>
              <a:r>
                <a:rPr lang="en-US" sz="788" dirty="0"/>
                <a:t>Method #3 Vs Method #4,  P =0.997</a:t>
              </a:r>
            </a:p>
            <a:p>
              <a:r>
                <a:rPr lang="en-US" sz="675" dirty="0"/>
                <a:t>*P-Values were calculated according to ANOVA test for equal variances</a:t>
              </a:r>
            </a:p>
            <a:p>
              <a:endParaRPr lang="en-US" sz="788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87D06A0-F244-4024-8080-4B590F4E18F6}"/>
                </a:ext>
              </a:extLst>
            </p:cNvPr>
            <p:cNvSpPr txBox="1"/>
            <p:nvPr/>
          </p:nvSpPr>
          <p:spPr>
            <a:xfrm>
              <a:off x="6618790" y="4955554"/>
              <a:ext cx="5416951" cy="18577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88" dirty="0"/>
                <a:t>Method #1 Vs Method #2,  P =0.093, P≤ 0.05</a:t>
              </a:r>
            </a:p>
            <a:p>
              <a:r>
                <a:rPr lang="en-US" sz="788" dirty="0"/>
                <a:t>Method #1 Vs Method #3,  P =0.624, </a:t>
              </a:r>
            </a:p>
            <a:p>
              <a:r>
                <a:rPr lang="en-US" sz="788" dirty="0"/>
                <a:t>Method #1 Vs Method #4,  P =0.170,</a:t>
              </a:r>
            </a:p>
            <a:p>
              <a:r>
                <a:rPr lang="en-US" sz="788" dirty="0"/>
                <a:t>Method #1 Vs Method #3,  P =0.498, </a:t>
              </a:r>
            </a:p>
            <a:p>
              <a:r>
                <a:rPr lang="en-US" sz="788" dirty="0"/>
                <a:t>Method #1 Vs Method #4,  P =0.856,</a:t>
              </a:r>
            </a:p>
            <a:p>
              <a:r>
                <a:rPr lang="en-US" sz="788" dirty="0"/>
                <a:t>Method #1 Vs Method #4,  P =0.604</a:t>
              </a:r>
            </a:p>
            <a:p>
              <a:r>
                <a:rPr lang="en-US" sz="675" dirty="0"/>
                <a:t>*P-Values were calculated according to ANOVA test for equal variances</a:t>
              </a:r>
            </a:p>
            <a:p>
              <a:endParaRPr lang="en-US" sz="788" dirty="0"/>
            </a:p>
          </p:txBody>
        </p:sp>
        <p:sp>
          <p:nvSpPr>
            <p:cNvPr id="24" name="CuadroTexto 7">
              <a:extLst>
                <a:ext uri="{FF2B5EF4-FFF2-40B4-BE49-F238E27FC236}">
                  <a16:creationId xmlns:a16="http://schemas.microsoft.com/office/drawing/2014/main" id="{72926181-7391-4203-A231-02BE524A5E57}"/>
                </a:ext>
              </a:extLst>
            </p:cNvPr>
            <p:cNvSpPr txBox="1"/>
            <p:nvPr/>
          </p:nvSpPr>
          <p:spPr>
            <a:xfrm>
              <a:off x="155796" y="774608"/>
              <a:ext cx="758604" cy="656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b="1" dirty="0"/>
                <a:t>A)</a:t>
              </a:r>
              <a:endParaRPr lang="en-US" b="1" dirty="0"/>
            </a:p>
          </p:txBody>
        </p:sp>
        <p:sp>
          <p:nvSpPr>
            <p:cNvPr id="25" name="CuadroTexto 8">
              <a:extLst>
                <a:ext uri="{FF2B5EF4-FFF2-40B4-BE49-F238E27FC236}">
                  <a16:creationId xmlns:a16="http://schemas.microsoft.com/office/drawing/2014/main" id="{30C668A4-EFEB-4944-9F9D-7D084A47497C}"/>
                </a:ext>
              </a:extLst>
            </p:cNvPr>
            <p:cNvSpPr txBox="1"/>
            <p:nvPr/>
          </p:nvSpPr>
          <p:spPr>
            <a:xfrm>
              <a:off x="6180406" y="774608"/>
              <a:ext cx="758604" cy="65659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MX" b="1" dirty="0"/>
                <a:t>B)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8671398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.pptx" id="{1E39CEC3-E423-4FB3-BDE8-ECFA3A5FB86C}" vid="{AA5D0353-88DC-447E-A034-4D9D51FBF58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302</TotalTime>
  <Words>207</Words>
  <Application>Microsoft Macintosh PowerPoint</Application>
  <PresentationFormat>Letter Paper (8.5x11 in)</PresentationFormat>
  <Paragraphs>4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テーマ</vt:lpstr>
      <vt:lpstr>PowerPoint Presentation</vt:lpstr>
      <vt:lpstr>PowerPoint Presentation</vt:lpstr>
      <vt:lpstr>PowerPoint Presentation</vt:lpstr>
    </vt:vector>
  </TitlesOfParts>
  <Company>DAIICHI SANKYO CO.,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UDA NOBUHISA / 増田 修久</dc:creator>
  <cp:lastModifiedBy>Sara Tomei</cp:lastModifiedBy>
  <cp:revision>59</cp:revision>
  <cp:lastPrinted>2019-04-10T12:46:37Z</cp:lastPrinted>
  <dcterms:created xsi:type="dcterms:W3CDTF">2017-11-13T23:57:55Z</dcterms:created>
  <dcterms:modified xsi:type="dcterms:W3CDTF">2019-04-14T12:21:22Z</dcterms:modified>
</cp:coreProperties>
</file>